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0" r:id="rId2"/>
  </p:sldIdLst>
  <p:sldSz cx="6858000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78"/>
    <p:restoredTop sz="91047"/>
  </p:normalViewPr>
  <p:slideViewPr>
    <p:cSldViewPr snapToGrid="0">
      <p:cViewPr varScale="1">
        <p:scale>
          <a:sx n="140" d="100"/>
          <a:sy n="140" d="100"/>
        </p:scale>
        <p:origin x="2232" y="184"/>
      </p:cViewPr>
      <p:guideLst/>
    </p:cSldViewPr>
  </p:slideViewPr>
  <p:notesTextViewPr>
    <p:cViewPr>
      <p:scale>
        <a:sx n="105" d="100"/>
        <a:sy n="10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FD6E84-851F-D648-A799-944239F62AE1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470025" y="1143000"/>
            <a:ext cx="3917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456B61-69CD-414B-A0E8-2C8E52593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84790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456B61-69CD-414B-A0E8-2C8E52593FA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98329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83861"/>
            <a:ext cx="5829300" cy="188023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2836605"/>
            <a:ext cx="5143500" cy="130391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8894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5244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287536"/>
            <a:ext cx="1478756" cy="457682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87536"/>
            <a:ext cx="4350544" cy="457682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7093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450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346420"/>
            <a:ext cx="5915025" cy="224653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614203"/>
            <a:ext cx="5915025" cy="118139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9089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437680"/>
            <a:ext cx="2914650" cy="34266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437680"/>
            <a:ext cx="2914650" cy="34266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9047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287537"/>
            <a:ext cx="5915025" cy="104388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323916"/>
            <a:ext cx="2901255" cy="64883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1972747"/>
            <a:ext cx="2901255" cy="290161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323916"/>
            <a:ext cx="2915543" cy="64883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1972747"/>
            <a:ext cx="2915543" cy="290161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1404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7157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991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60045"/>
            <a:ext cx="2211884" cy="1260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777598"/>
            <a:ext cx="3471863" cy="38379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20202"/>
            <a:ext cx="2211884" cy="3001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804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60045"/>
            <a:ext cx="2211884" cy="1260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777598"/>
            <a:ext cx="3471863" cy="38379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20202"/>
            <a:ext cx="2211884" cy="3001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7827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287537"/>
            <a:ext cx="5915025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437680"/>
            <a:ext cx="5915025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5005627"/>
            <a:ext cx="1543050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2C8A8-46CD-5249-9BD3-B6A5DF78392B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5005627"/>
            <a:ext cx="2314575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5005627"/>
            <a:ext cx="1543050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B1F350-EF18-9648-A1FD-DEA91AF68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275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A841E183-E706-E0EF-4E6E-C183F0D3E103}"/>
              </a:ext>
            </a:extLst>
          </p:cNvPr>
          <p:cNvSpPr txBox="1">
            <a:spLocks/>
          </p:cNvSpPr>
          <p:nvPr/>
        </p:nvSpPr>
        <p:spPr>
          <a:xfrm>
            <a:off x="1836424" y="919968"/>
            <a:ext cx="1204977" cy="1692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Helvetica" pitchFamily="2" charset="0"/>
              </a:rPr>
              <a:t>OFT (PTA and PA-VSD)	205</a:t>
            </a:r>
            <a:endParaRPr kumimoji="1" lang="ja-JP" altLang="en-US" sz="500">
              <a:latin typeface="Helvetica" pitchFamily="2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24C9D865-E43A-9F31-AEA5-FF24D240C087}"/>
              </a:ext>
            </a:extLst>
          </p:cNvPr>
          <p:cNvSpPr txBox="1"/>
          <p:nvPr/>
        </p:nvSpPr>
        <p:spPr>
          <a:xfrm>
            <a:off x="1824844" y="2003591"/>
            <a:ext cx="1164101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Helvetica" pitchFamily="2" charset="0"/>
              </a:rPr>
              <a:t>Genetic disorder (Total)	6</a:t>
            </a:r>
          </a:p>
          <a:p>
            <a:r>
              <a:rPr kumimoji="1" lang="en-US" altLang="ja-JP" sz="500" dirty="0">
                <a:latin typeface="Helvetica" pitchFamily="2" charset="0"/>
              </a:rPr>
              <a:t>   - 22q11.2 deletion syndrome	5</a:t>
            </a:r>
            <a:endParaRPr kumimoji="1" lang="ja-JP" altLang="en-US" sz="500">
              <a:latin typeface="Helvetica" pitchFamily="2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2FC098E4-B741-046F-AA69-50DCBF117B48}"/>
              </a:ext>
            </a:extLst>
          </p:cNvPr>
          <p:cNvSpPr txBox="1"/>
          <p:nvPr/>
        </p:nvSpPr>
        <p:spPr>
          <a:xfrm>
            <a:off x="4235632" y="2003591"/>
            <a:ext cx="1168488" cy="25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Helvetica" pitchFamily="2" charset="0"/>
              </a:rPr>
              <a:t>Genetic disorder (Total)	77</a:t>
            </a:r>
          </a:p>
          <a:p>
            <a:r>
              <a:rPr kumimoji="1" lang="en-US" altLang="ja-JP" sz="500" dirty="0">
                <a:latin typeface="Helvetica" pitchFamily="2" charset="0"/>
              </a:rPr>
              <a:t>  - 22q11.2 deletion syndrome	74</a:t>
            </a:r>
            <a:endParaRPr kumimoji="1" lang="ja-JP" altLang="en-US" sz="500">
              <a:latin typeface="Helvetica" pitchFamily="2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4DE10333-E15C-D1B9-7FB2-259EA6BCEB6E}"/>
              </a:ext>
            </a:extLst>
          </p:cNvPr>
          <p:cNvSpPr txBox="1"/>
          <p:nvPr/>
        </p:nvSpPr>
        <p:spPr>
          <a:xfrm>
            <a:off x="1824844" y="2603789"/>
            <a:ext cx="1143262" cy="1692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Helvetica" pitchFamily="2" charset="0"/>
              </a:rPr>
              <a:t>Poor DNA quality	5</a:t>
            </a:r>
            <a:endParaRPr kumimoji="1" lang="ja-JP" altLang="en-US" sz="500">
              <a:latin typeface="Helvetica" pitchFamily="2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DD8E4E0-C8F2-8B5A-C7EC-E20FDD34AE30}"/>
              </a:ext>
            </a:extLst>
          </p:cNvPr>
          <p:cNvSpPr txBox="1"/>
          <p:nvPr/>
        </p:nvSpPr>
        <p:spPr>
          <a:xfrm>
            <a:off x="4235632" y="2603789"/>
            <a:ext cx="1178528" cy="1692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Helvetica" pitchFamily="2" charset="0"/>
              </a:rPr>
              <a:t>Poor DNA quality	13</a:t>
            </a:r>
            <a:endParaRPr kumimoji="1" lang="ja-JP" altLang="en-US" sz="500">
              <a:latin typeface="Helvetica" pitchFamily="2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4145D3B8-177B-5CA9-5A0B-4DF7EA8A5F90}"/>
              </a:ext>
            </a:extLst>
          </p:cNvPr>
          <p:cNvSpPr txBox="1"/>
          <p:nvPr/>
        </p:nvSpPr>
        <p:spPr>
          <a:xfrm>
            <a:off x="859650" y="1466576"/>
            <a:ext cx="745481" cy="1692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Helvetica" pitchFamily="2" charset="0"/>
              </a:rPr>
              <a:t>PTA	37</a:t>
            </a:r>
            <a:endParaRPr kumimoji="1" lang="ja-JP" altLang="en-US" sz="500">
              <a:latin typeface="Helvetica" pitchFamily="2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2AC45AC-D26C-A1FA-86AB-DBC5786F6C88}"/>
              </a:ext>
            </a:extLst>
          </p:cNvPr>
          <p:cNvSpPr txBox="1"/>
          <p:nvPr/>
        </p:nvSpPr>
        <p:spPr>
          <a:xfrm>
            <a:off x="3272695" y="1466576"/>
            <a:ext cx="745481" cy="1692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Helvetica" pitchFamily="2" charset="0"/>
              </a:rPr>
              <a:t>PA-VSD	168</a:t>
            </a:r>
            <a:endParaRPr kumimoji="1" lang="ja-JP" altLang="en-US" sz="500">
              <a:latin typeface="Helvetica" pitchFamily="2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7B092FC-8154-6066-794F-2EA55668CF2F}"/>
              </a:ext>
            </a:extLst>
          </p:cNvPr>
          <p:cNvSpPr txBox="1"/>
          <p:nvPr/>
        </p:nvSpPr>
        <p:spPr>
          <a:xfrm>
            <a:off x="859650" y="3131751"/>
            <a:ext cx="745481" cy="1692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Helvetica" pitchFamily="2" charset="0"/>
              </a:rPr>
              <a:t>Analyzed	26</a:t>
            </a:r>
            <a:endParaRPr kumimoji="1" lang="ja-JP" altLang="en-US" sz="500">
              <a:latin typeface="Helvetica" pitchFamily="2" charset="0"/>
            </a:endParaRPr>
          </a:p>
        </p:txBody>
      </p: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DB463A10-620D-053C-D5CE-65A359A2E0CC}"/>
              </a:ext>
            </a:extLst>
          </p:cNvPr>
          <p:cNvCxnSpPr>
            <a:cxnSpLocks/>
            <a:stCxn id="48" idx="2"/>
            <a:endCxn id="53" idx="0"/>
          </p:cNvCxnSpPr>
          <p:nvPr/>
        </p:nvCxnSpPr>
        <p:spPr>
          <a:xfrm flipH="1">
            <a:off x="1232391" y="1089245"/>
            <a:ext cx="1206522" cy="37733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F77A1B6D-DB7C-DAFB-7F28-2A4659A20CAA}"/>
              </a:ext>
            </a:extLst>
          </p:cNvPr>
          <p:cNvCxnSpPr>
            <a:cxnSpLocks/>
            <a:stCxn id="48" idx="2"/>
            <a:endCxn id="54" idx="0"/>
          </p:cNvCxnSpPr>
          <p:nvPr/>
        </p:nvCxnSpPr>
        <p:spPr>
          <a:xfrm>
            <a:off x="2438913" y="1089245"/>
            <a:ext cx="1206523" cy="37733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矢印コネクタ 58">
            <a:extLst>
              <a:ext uri="{FF2B5EF4-FFF2-40B4-BE49-F238E27FC236}">
                <a16:creationId xmlns:a16="http://schemas.microsoft.com/office/drawing/2014/main" id="{5F4E8B2E-EA83-DC00-BE0B-DF852549BACA}"/>
              </a:ext>
            </a:extLst>
          </p:cNvPr>
          <p:cNvCxnSpPr>
            <a:cxnSpLocks/>
            <a:stCxn id="54" idx="2"/>
          </p:cNvCxnSpPr>
          <p:nvPr/>
        </p:nvCxnSpPr>
        <p:spPr>
          <a:xfrm>
            <a:off x="3645436" y="1635853"/>
            <a:ext cx="0" cy="149613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矢印コネクタ 59">
            <a:extLst>
              <a:ext uri="{FF2B5EF4-FFF2-40B4-BE49-F238E27FC236}">
                <a16:creationId xmlns:a16="http://schemas.microsoft.com/office/drawing/2014/main" id="{0B534DF2-A8CA-5B77-0FB0-EE7A435F59CA}"/>
              </a:ext>
            </a:extLst>
          </p:cNvPr>
          <p:cNvCxnSpPr>
            <a:cxnSpLocks/>
            <a:stCxn id="53" idx="2"/>
            <a:endCxn id="55" idx="0"/>
          </p:cNvCxnSpPr>
          <p:nvPr/>
        </p:nvCxnSpPr>
        <p:spPr>
          <a:xfrm>
            <a:off x="1232391" y="1635853"/>
            <a:ext cx="0" cy="149589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曲線コネクタ 62">
            <a:extLst>
              <a:ext uri="{FF2B5EF4-FFF2-40B4-BE49-F238E27FC236}">
                <a16:creationId xmlns:a16="http://schemas.microsoft.com/office/drawing/2014/main" id="{9FF43745-0397-108F-26C3-E3F36540E96D}"/>
              </a:ext>
            </a:extLst>
          </p:cNvPr>
          <p:cNvCxnSpPr>
            <a:cxnSpLocks/>
          </p:cNvCxnSpPr>
          <p:nvPr/>
        </p:nvCxnSpPr>
        <p:spPr>
          <a:xfrm rot="16200000" flipH="1">
            <a:off x="3766958" y="1661780"/>
            <a:ext cx="352593" cy="586402"/>
          </a:xfrm>
          <a:prstGeom prst="curved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曲線コネクタ 63">
            <a:extLst>
              <a:ext uri="{FF2B5EF4-FFF2-40B4-BE49-F238E27FC236}">
                <a16:creationId xmlns:a16="http://schemas.microsoft.com/office/drawing/2014/main" id="{B2EDE01A-0B50-435F-2602-8E636CC82602}"/>
              </a:ext>
            </a:extLst>
          </p:cNvPr>
          <p:cNvCxnSpPr>
            <a:cxnSpLocks/>
          </p:cNvCxnSpPr>
          <p:nvPr/>
        </p:nvCxnSpPr>
        <p:spPr>
          <a:xfrm rot="16200000" flipH="1">
            <a:off x="3768310" y="2237045"/>
            <a:ext cx="352593" cy="586402"/>
          </a:xfrm>
          <a:prstGeom prst="curved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曲線コネクタ 65">
            <a:extLst>
              <a:ext uri="{FF2B5EF4-FFF2-40B4-BE49-F238E27FC236}">
                <a16:creationId xmlns:a16="http://schemas.microsoft.com/office/drawing/2014/main" id="{A1D7C74C-9AFA-BAE4-FAE9-CC0BCE95C7B2}"/>
              </a:ext>
            </a:extLst>
          </p:cNvPr>
          <p:cNvCxnSpPr>
            <a:cxnSpLocks/>
          </p:cNvCxnSpPr>
          <p:nvPr/>
        </p:nvCxnSpPr>
        <p:spPr>
          <a:xfrm rot="16200000" flipH="1">
            <a:off x="1355079" y="1668401"/>
            <a:ext cx="352593" cy="586402"/>
          </a:xfrm>
          <a:prstGeom prst="curved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曲線コネクタ 66">
            <a:extLst>
              <a:ext uri="{FF2B5EF4-FFF2-40B4-BE49-F238E27FC236}">
                <a16:creationId xmlns:a16="http://schemas.microsoft.com/office/drawing/2014/main" id="{71A9490A-F1FE-8DC9-0917-1919F30CD584}"/>
              </a:ext>
            </a:extLst>
          </p:cNvPr>
          <p:cNvCxnSpPr>
            <a:cxnSpLocks/>
          </p:cNvCxnSpPr>
          <p:nvPr/>
        </p:nvCxnSpPr>
        <p:spPr>
          <a:xfrm rot="16200000" flipH="1">
            <a:off x="1354694" y="2231750"/>
            <a:ext cx="352593" cy="586402"/>
          </a:xfrm>
          <a:prstGeom prst="curved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341CF68-A066-29FB-EBCC-2DA1433ED6C7}"/>
              </a:ext>
            </a:extLst>
          </p:cNvPr>
          <p:cNvSpPr txBox="1"/>
          <p:nvPr/>
        </p:nvSpPr>
        <p:spPr>
          <a:xfrm>
            <a:off x="193964" y="508060"/>
            <a:ext cx="58849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Figure S1</a:t>
            </a:r>
            <a:r>
              <a:rPr kumimoji="1" lang="en-US" altLang="ja-JP" sz="900">
                <a:latin typeface="Helvetica" pitchFamily="2" charset="0"/>
              </a:rPr>
              <a:t>. </a:t>
            </a:r>
            <a:r>
              <a:rPr lang="en-US" altLang="ja-JP" sz="900">
                <a:latin typeface="Helvetica" pitchFamily="2" charset="0"/>
                <a:ea typeface="游明朝" panose="02020400000000000000" pitchFamily="18" charset="-128"/>
              </a:rPr>
              <a:t>Flowchart of </a:t>
            </a:r>
            <a:r>
              <a:rPr lang="en-US" altLang="ja-JP" sz="900" dirty="0">
                <a:latin typeface="Helvetica" pitchFamily="2" charset="0"/>
                <a:ea typeface="游明朝" panose="02020400000000000000" pitchFamily="18" charset="-128"/>
              </a:rPr>
              <a:t>the case selection process for analysis in the Japanese genome bank for heart disease</a:t>
            </a:r>
            <a:r>
              <a:rPr lang="ja-JP" altLang="ja-JP" sz="900" dirty="0">
                <a:latin typeface="Helvetica" pitchFamily="2" charset="0"/>
              </a:rPr>
              <a:t> </a:t>
            </a:r>
            <a:endParaRPr kumimoji="1" lang="ja-JP" altLang="en-US" sz="900" dirty="0">
              <a:latin typeface="Helvetica" pitchFamily="2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A306437-EED8-A1BD-A49B-478232D89BC6}"/>
              </a:ext>
            </a:extLst>
          </p:cNvPr>
          <p:cNvSpPr txBox="1"/>
          <p:nvPr/>
        </p:nvSpPr>
        <p:spPr>
          <a:xfrm>
            <a:off x="3272695" y="3131751"/>
            <a:ext cx="745481" cy="1692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Helvetica" pitchFamily="2" charset="0"/>
              </a:rPr>
              <a:t>Analyzed	78</a:t>
            </a:r>
            <a:endParaRPr kumimoji="1" lang="ja-JP" altLang="en-US" sz="500"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405E218-E0E1-CB65-779C-D7A592E40CCE}"/>
              </a:ext>
            </a:extLst>
          </p:cNvPr>
          <p:cNvSpPr txBox="1"/>
          <p:nvPr/>
        </p:nvSpPr>
        <p:spPr>
          <a:xfrm>
            <a:off x="1899762" y="3531961"/>
            <a:ext cx="4179146" cy="18466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Helvetica" pitchFamily="2" charset="0"/>
              </a:rPr>
              <a:t>OFT, outflow tract defect; PA-VSD, pulmonary atresia with ventricular septal defect; PTA, persistent truncus arteriosus</a:t>
            </a:r>
            <a:endParaRPr kumimoji="1" lang="ja-JP" altLang="en-US" sz="6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1558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573</TotalTime>
  <Words>98</Words>
  <Application>Microsoft Macintosh PowerPoint</Application>
  <PresentationFormat>ユーザー設定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忠 井上</dc:creator>
  <cp:lastModifiedBy>忠 井上</cp:lastModifiedBy>
  <cp:revision>43</cp:revision>
  <cp:lastPrinted>2023-10-05T02:01:06Z</cp:lastPrinted>
  <dcterms:created xsi:type="dcterms:W3CDTF">2023-09-14T07:53:19Z</dcterms:created>
  <dcterms:modified xsi:type="dcterms:W3CDTF">2023-11-09T15:41:00Z</dcterms:modified>
</cp:coreProperties>
</file>